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6" d="100"/>
          <a:sy n="96" d="100"/>
        </p:scale>
        <p:origin x="2622" y="-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080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63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8280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206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733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761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923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557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981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214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381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1D156F-90C0-4C6E-AC89-87EBDFB0C7C6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AB16D6-EA7E-49FB-9D32-D40BB33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956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Group 73">
            <a:extLst>
              <a:ext uri="{FF2B5EF4-FFF2-40B4-BE49-F238E27FC236}">
                <a16:creationId xmlns:a16="http://schemas.microsoft.com/office/drawing/2014/main" id="{AC1A4570-C938-01F5-82F9-E42A74AEE1EA}"/>
              </a:ext>
            </a:extLst>
          </p:cNvPr>
          <p:cNvGrpSpPr/>
          <p:nvPr/>
        </p:nvGrpSpPr>
        <p:grpSpPr>
          <a:xfrm>
            <a:off x="821129" y="1765322"/>
            <a:ext cx="4905375" cy="3543300"/>
            <a:chOff x="917604" y="1960453"/>
            <a:chExt cx="4905375" cy="3543300"/>
          </a:xfrm>
        </p:grpSpPr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FFF002DD-A146-3BFD-898F-01653642716C}"/>
                </a:ext>
              </a:extLst>
            </p:cNvPr>
            <p:cNvGrpSpPr/>
            <p:nvPr/>
          </p:nvGrpSpPr>
          <p:grpSpPr>
            <a:xfrm>
              <a:off x="917604" y="1960453"/>
              <a:ext cx="4905375" cy="3543300"/>
              <a:chOff x="1265334" y="1908937"/>
              <a:chExt cx="4905375" cy="3543300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62AEF6DA-A1B0-6414-C846-34CE0115EACC}"/>
                  </a:ext>
                </a:extLst>
              </p:cNvPr>
              <p:cNvGrpSpPr/>
              <p:nvPr/>
            </p:nvGrpSpPr>
            <p:grpSpPr>
              <a:xfrm>
                <a:off x="1265334" y="1908937"/>
                <a:ext cx="4905375" cy="3543300"/>
                <a:chOff x="779542" y="801743"/>
                <a:chExt cx="4905375" cy="3543300"/>
              </a:xfrm>
            </p:grpSpPr>
            <p:pic>
              <p:nvPicPr>
                <p:cNvPr id="2" name="Picture 1">
                  <a:extLst>
                    <a:ext uri="{FF2B5EF4-FFF2-40B4-BE49-F238E27FC236}">
                      <a16:creationId xmlns:a16="http://schemas.microsoft.com/office/drawing/2014/main" id="{833F11DA-5EE7-94B2-1002-DD7A5B51243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779542" y="801743"/>
                  <a:ext cx="4905375" cy="3543300"/>
                </a:xfrm>
                <a:prstGeom prst="rect">
                  <a:avLst/>
                </a:prstGeom>
              </p:spPr>
            </p:pic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1E9320E3-ED2C-3D12-D725-39CD4A57F2AE}"/>
                    </a:ext>
                  </a:extLst>
                </p:cNvPr>
                <p:cNvSpPr txBox="1"/>
                <p:nvPr/>
              </p:nvSpPr>
              <p:spPr>
                <a:xfrm>
                  <a:off x="3172595" y="1981046"/>
                  <a:ext cx="62549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gZFP48</a:t>
                  </a:r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AD68F827-A13E-357C-0A3E-DAF528875ED9}"/>
                    </a:ext>
                  </a:extLst>
                </p:cNvPr>
                <p:cNvSpPr txBox="1"/>
                <p:nvPr/>
              </p:nvSpPr>
              <p:spPr>
                <a:xfrm rot="19440000">
                  <a:off x="3838813" y="2079873"/>
                  <a:ext cx="62549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gZFP79</a:t>
                  </a:r>
                </a:p>
              </p:txBody>
            </p:sp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DF58ECFD-FC3E-24E8-975D-758E9D7E21E7}"/>
                    </a:ext>
                  </a:extLst>
                </p:cNvPr>
                <p:cNvGrpSpPr/>
                <p:nvPr/>
              </p:nvGrpSpPr>
              <p:grpSpPr>
                <a:xfrm>
                  <a:off x="2883277" y="2413405"/>
                  <a:ext cx="1976345" cy="1673371"/>
                  <a:chOff x="2883277" y="2413405"/>
                  <a:chExt cx="1976345" cy="1673371"/>
                </a:xfrm>
              </p:grpSpPr>
              <p:sp>
                <p:nvSpPr>
                  <p:cNvPr id="3" name="TextBox 2">
                    <a:extLst>
                      <a:ext uri="{FF2B5EF4-FFF2-40B4-BE49-F238E27FC236}">
                        <a16:creationId xmlns:a16="http://schemas.microsoft.com/office/drawing/2014/main" id="{9601585E-AE6A-066C-6F14-47AEE7EE1973}"/>
                      </a:ext>
                    </a:extLst>
                  </p:cNvPr>
                  <p:cNvSpPr txBox="1"/>
                  <p:nvPr/>
                </p:nvSpPr>
                <p:spPr>
                  <a:xfrm>
                    <a:off x="4234130" y="2413405"/>
                    <a:ext cx="62549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i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gZFP82</a:t>
                    </a:r>
                  </a:p>
                </p:txBody>
              </p:sp>
              <p:cxnSp>
                <p:nvCxnSpPr>
                  <p:cNvPr id="7" name="Straight Connector 6">
                    <a:extLst>
                      <a:ext uri="{FF2B5EF4-FFF2-40B4-BE49-F238E27FC236}">
                        <a16:creationId xmlns:a16="http://schemas.microsoft.com/office/drawing/2014/main" id="{589545D6-69A3-BDA7-4269-C2FCD9657BA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619101" y="3100115"/>
                    <a:ext cx="859470" cy="667267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" name="Straight Connector 9">
                    <a:extLst>
                      <a:ext uri="{FF2B5EF4-FFF2-40B4-BE49-F238E27FC236}">
                        <a16:creationId xmlns:a16="http://schemas.microsoft.com/office/drawing/2014/main" id="{0C3973C0-6884-66B6-BABD-DE4E0D456AA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135068" y="3151259"/>
                    <a:ext cx="381750" cy="935517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" name="Straight Connector 10">
                    <a:extLst>
                      <a:ext uri="{FF2B5EF4-FFF2-40B4-BE49-F238E27FC236}">
                        <a16:creationId xmlns:a16="http://schemas.microsoft.com/office/drawing/2014/main" id="{BA91CBD9-1F48-19EF-6B12-0E3FB9B9B5F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57259" y="3051641"/>
                    <a:ext cx="753721" cy="187923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" name="Straight Connector 11">
                    <a:extLst>
                      <a:ext uri="{FF2B5EF4-FFF2-40B4-BE49-F238E27FC236}">
                        <a16:creationId xmlns:a16="http://schemas.microsoft.com/office/drawing/2014/main" id="{0270124D-A7D0-8ADE-B6C1-6043B2A3418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621585" y="3188006"/>
                    <a:ext cx="174909" cy="525336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" name="Straight Connector 13">
                    <a:extLst>
                      <a:ext uri="{FF2B5EF4-FFF2-40B4-BE49-F238E27FC236}">
                        <a16:creationId xmlns:a16="http://schemas.microsoft.com/office/drawing/2014/main" id="{140BC4F2-A391-E144-6CCA-52A55BEE947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883277" y="3088840"/>
                    <a:ext cx="594607" cy="326829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4267827E-1E61-BAFF-C215-933A8DC7570F}"/>
                  </a:ext>
                </a:extLst>
              </p:cNvPr>
              <p:cNvSpPr txBox="1"/>
              <p:nvPr/>
            </p:nvSpPr>
            <p:spPr>
              <a:xfrm>
                <a:off x="2867244" y="4469866"/>
                <a:ext cx="77457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ZFP63-04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4601D09B-8832-6EF6-CC3D-63DCCFE6EF3B}"/>
                  </a:ext>
                </a:extLst>
              </p:cNvPr>
              <p:cNvSpPr txBox="1"/>
              <p:nvPr/>
            </p:nvSpPr>
            <p:spPr>
              <a:xfrm>
                <a:off x="3241223" y="5140973"/>
                <a:ext cx="6254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ZFP30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466DADC1-E2CE-E09F-B5C9-2394A9207670}"/>
                  </a:ext>
                </a:extLst>
              </p:cNvPr>
              <p:cNvSpPr txBox="1"/>
              <p:nvPr/>
            </p:nvSpPr>
            <p:spPr>
              <a:xfrm>
                <a:off x="4060826" y="4750109"/>
                <a:ext cx="77457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ZFP01-02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3BD08DCF-BD41-6E44-3262-03661E60E102}"/>
                  </a:ext>
                </a:extLst>
              </p:cNvPr>
              <p:cNvSpPr txBox="1"/>
              <p:nvPr/>
            </p:nvSpPr>
            <p:spPr>
              <a:xfrm>
                <a:off x="4661545" y="4825382"/>
                <a:ext cx="6254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ZFP87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7623699C-F89D-DFED-489F-117D6C7CA4D0}"/>
                  </a:ext>
                </a:extLst>
              </p:cNvPr>
              <p:cNvSpPr txBox="1"/>
              <p:nvPr/>
            </p:nvSpPr>
            <p:spPr>
              <a:xfrm>
                <a:off x="4568175" y="4292956"/>
                <a:ext cx="6832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ZFP114</a:t>
                </a:r>
              </a:p>
            </p:txBody>
          </p:sp>
        </p:grp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4ED7C659-168F-26E3-7E4D-7295F66989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84861" y="3483683"/>
              <a:ext cx="187159" cy="218603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7239910B-6C7A-FCCD-3022-0E0C39502566}"/>
              </a:ext>
            </a:extLst>
          </p:cNvPr>
          <p:cNvSpPr txBox="1"/>
          <p:nvPr/>
        </p:nvSpPr>
        <p:spPr>
          <a:xfrm>
            <a:off x="308084" y="5394269"/>
            <a:ext cx="59314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6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otential hub genes identified in the network of the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ZFP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family. The eight hub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Z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of the network are indicated with larger light blue balls and named in red color bold font. The hub genes were identified at criteria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01, connectivity ≥ 30, and the percentage of the genes in the network ≤ 5.0%.</a:t>
            </a:r>
          </a:p>
        </p:txBody>
      </p:sp>
    </p:spTree>
    <p:extLst>
      <p:ext uri="{BB962C8B-B14F-4D97-AF65-F5344CB8AC3E}">
        <p14:creationId xmlns:p14="http://schemas.microsoft.com/office/powerpoint/2010/main" val="3945466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</TotalTime>
  <Words>77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AMU Soil &amp; Crop Sciences Dept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Meiping</dc:creator>
  <cp:lastModifiedBy>Zhang, Hongbin</cp:lastModifiedBy>
  <cp:revision>27</cp:revision>
  <dcterms:created xsi:type="dcterms:W3CDTF">2021-04-02T20:16:47Z</dcterms:created>
  <dcterms:modified xsi:type="dcterms:W3CDTF">2022-05-17T22:09:00Z</dcterms:modified>
</cp:coreProperties>
</file>